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FAB845-4DF3-410A-A55E-815E60AD37F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F6DBB6-2A5F-46B1-A6F4-E10D94FFDB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CB41DD-D666-4E28-82D5-BC11928CAA0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93A82B-7B68-40CE-9343-471E3C66727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4D4FD7-6708-466C-9C43-410FF16841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A536B4-9407-44C1-9B50-160CE84A1E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459AB5-7EC5-4798-B098-21C90C3AA9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243A5A-D5B4-4A63-B319-EE4E695620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9E4D72-5FB9-4E3C-9D8E-E3A9E75375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D158A0-3CB3-427F-8BB4-15F11EE6A9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E656A0-C404-4576-97BD-76C5B78AEE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6203A0-4F49-47F6-B153-D20D3A6792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C1932B-D633-4047-8A96-765A953A747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 flipH="1">
            <a:off x="642240" y="2438280"/>
            <a:ext cx="7882920" cy="1526760"/>
          </a:xfrm>
          <a:custGeom>
            <a:avLst/>
            <a:gdLst/>
            <a:ahLst/>
            <a:rect l="l" t="t" r="r" b="b"/>
            <a:pathLst>
              <a:path stroke="0" w="21600" h="21600">
                <a:moveTo>
                  <a:pt x="1852" y="4752"/>
                </a:moveTo>
                <a:arcTo wR="10800" hR="10800" stAng="-8756771" swAng="7156806"/>
                <a:lnTo>
                  <a:pt x="10800" y="10800"/>
                </a:lnTo>
                <a:close/>
              </a:path>
              <a:path fill="none" w="21600" h="21600">
                <a:moveTo>
                  <a:pt x="1852" y="4752"/>
                </a:moveTo>
                <a:arcTo wR="10800" hR="10800" stAng="-8756771" swAng="7156806"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4199040" y="2274840"/>
            <a:ext cx="133200" cy="327240"/>
          </a:xfrm>
          <a:prstGeom prst="ellipse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316400" y="2274840"/>
            <a:ext cx="133200" cy="327240"/>
          </a:xfrm>
          <a:prstGeom prst="ellipse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385520" y="2193840"/>
            <a:ext cx="67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py123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5" name=""/>
          <p:cNvGrpSpPr/>
          <p:nvPr/>
        </p:nvGrpSpPr>
        <p:grpSpPr>
          <a:xfrm>
            <a:off x="4200480" y="2602080"/>
            <a:ext cx="250920" cy="153360"/>
            <a:chOff x="4200480" y="2602080"/>
            <a:chExt cx="250920" cy="153360"/>
          </a:xfrm>
        </p:grpSpPr>
        <p:sp>
          <p:nvSpPr>
            <p:cNvPr id="46" name=""/>
            <p:cNvSpPr/>
            <p:nvPr/>
          </p:nvSpPr>
          <p:spPr>
            <a:xfrm>
              <a:off x="4200480" y="2602080"/>
              <a:ext cx="123840" cy="150480"/>
            </a:xfrm>
            <a:prstGeom prst="ellipse">
              <a:avLst/>
            </a:prstGeom>
            <a:solidFill>
              <a:srgbClr val="99cc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327560" y="2604960"/>
              <a:ext cx="123840" cy="150480"/>
            </a:xfrm>
            <a:prstGeom prst="ellipse">
              <a:avLst/>
            </a:prstGeom>
            <a:solidFill>
              <a:srgbClr val="99cc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8" name=""/>
          <p:cNvSpPr/>
          <p:nvPr/>
        </p:nvSpPr>
        <p:spPr>
          <a:xfrm>
            <a:off x="4393440" y="2570040"/>
            <a:ext cx="67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py123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802680" y="1386000"/>
            <a:ext cx="1082880" cy="246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xidative stres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4324320" y="1643040"/>
            <a:ext cx="0" cy="603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701880" y="5264280"/>
            <a:ext cx="143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5454720" y="5248440"/>
            <a:ext cx="1438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062080" y="5249880"/>
            <a:ext cx="1438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433600" y="5070600"/>
            <a:ext cx="425520" cy="187200"/>
          </a:xfrm>
          <a:custGeom>
            <a:avLst/>
            <a:gdLst>
              <a:gd name="textAreaLeft" fmla="*/ 0 w 425520"/>
              <a:gd name="textAreaRight" fmla="*/ 425880 w 425520"/>
              <a:gd name="textAreaTop" fmla="*/ 0 h 187200"/>
              <a:gd name="textAreaBottom" fmla="*/ 187560 h 1872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ja-JP" sz="1000" spc="-1" strike="noStrike">
                <a:solidFill>
                  <a:srgbClr val="000000"/>
                </a:solidFill>
                <a:latin typeface="Arial"/>
              </a:rPr>
              <a:t>htr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156200" y="5073480"/>
            <a:ext cx="425160" cy="187560"/>
          </a:xfrm>
          <a:custGeom>
            <a:avLst/>
            <a:gdLst>
              <a:gd name="textAreaLeft" fmla="*/ 0 w 425160"/>
              <a:gd name="textAreaRight" fmla="*/ 425520 w 425160"/>
              <a:gd name="textAreaTop" fmla="*/ 0 h 187560"/>
              <a:gd name="textAreaBottom" fmla="*/ 187920 h 1875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ja-JP" sz="1000" spc="-1" strike="noStrike">
                <a:solidFill>
                  <a:srgbClr val="000000"/>
                </a:solidFill>
                <a:latin typeface="Arial"/>
              </a:rPr>
              <a:t>nrd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5881680" y="5057640"/>
            <a:ext cx="425520" cy="187560"/>
          </a:xfrm>
          <a:custGeom>
            <a:avLst/>
            <a:gdLst>
              <a:gd name="textAreaLeft" fmla="*/ 0 w 425520"/>
              <a:gd name="textAreaRight" fmla="*/ 425880 w 425520"/>
              <a:gd name="textAreaTop" fmla="*/ 0 h 187560"/>
              <a:gd name="textAreaBottom" fmla="*/ 187920 h 1875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polA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341960" y="2805120"/>
            <a:ext cx="0" cy="219384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379760" y="2763720"/>
            <a:ext cx="1651320" cy="221148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610000" y="5264280"/>
            <a:ext cx="1420560" cy="593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961080" y="5967360"/>
            <a:ext cx="869400" cy="27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espon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4332240" y="5273640"/>
            <a:ext cx="0" cy="6397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H="1">
            <a:off x="4944600" y="5291280"/>
            <a:ext cx="1127160" cy="576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8300520" y="6583320"/>
            <a:ext cx="843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408400" y="2225520"/>
            <a:ext cx="133200" cy="327240"/>
          </a:xfrm>
          <a:prstGeom prst="ellipse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525760" y="2225520"/>
            <a:ext cx="133200" cy="327240"/>
          </a:xfrm>
          <a:prstGeom prst="ellipse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698480" y="1789200"/>
            <a:ext cx="11718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ther two component system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7" name=""/>
          <p:cNvGrpSpPr/>
          <p:nvPr/>
        </p:nvGrpSpPr>
        <p:grpSpPr>
          <a:xfrm>
            <a:off x="2409840" y="2552760"/>
            <a:ext cx="250920" cy="154080"/>
            <a:chOff x="2409840" y="2552760"/>
            <a:chExt cx="250920" cy="154080"/>
          </a:xfrm>
        </p:grpSpPr>
        <p:sp>
          <p:nvSpPr>
            <p:cNvPr id="68" name=""/>
            <p:cNvSpPr/>
            <p:nvPr/>
          </p:nvSpPr>
          <p:spPr>
            <a:xfrm>
              <a:off x="2409840" y="2552760"/>
              <a:ext cx="123840" cy="150840"/>
            </a:xfrm>
            <a:prstGeom prst="ellipse">
              <a:avLst/>
            </a:prstGeom>
            <a:solidFill>
              <a:srgbClr val="99336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2536920" y="2556000"/>
              <a:ext cx="123840" cy="150840"/>
            </a:xfrm>
            <a:prstGeom prst="ellipse">
              <a:avLst/>
            </a:prstGeom>
            <a:solidFill>
              <a:srgbClr val="99336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0" name=""/>
          <p:cNvSpPr/>
          <p:nvPr/>
        </p:nvSpPr>
        <p:spPr>
          <a:xfrm flipH="1">
            <a:off x="2533680" y="1619280"/>
            <a:ext cx="1233360" cy="63972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2533680" y="2789280"/>
            <a:ext cx="0" cy="219384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911320" y="3357720"/>
            <a:ext cx="693720" cy="6141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ther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nsing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ystems?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flipH="1">
            <a:off x="3317760" y="1622520"/>
            <a:ext cx="603360" cy="173520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 flipH="1">
            <a:off x="2619000" y="4011480"/>
            <a:ext cx="398520" cy="90648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7-11T08:19:53Z</dcterms:created>
  <dc:creator>ichiro_tatsuno</dc:creator>
  <dc:description/>
  <dc:language>en-US</dc:language>
  <cp:lastModifiedBy>ichiro_tatsuno</cp:lastModifiedBy>
  <dcterms:modified xsi:type="dcterms:W3CDTF">2014-03-31T05:10:26Z</dcterms:modified>
  <cp:revision>18</cp:revision>
  <dc:subject/>
  <dc:title>スライド 1</dc:title>
</cp:coreProperties>
</file>